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</p:sldIdLst>
  <p:sldSz cx="109728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6" d="100"/>
          <a:sy n="36" d="100"/>
        </p:scale>
        <p:origin x="143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2244726"/>
            <a:ext cx="9326880" cy="4775200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7204076"/>
            <a:ext cx="8229600" cy="3311524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7457C-3A5A-40D5-82FA-555B7446A59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54632-73CF-468C-9C4F-0532F376B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574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7457C-3A5A-40D5-82FA-555B7446A59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54632-73CF-468C-9C4F-0532F376B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7663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52411" y="730250"/>
            <a:ext cx="2366010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4381" y="730250"/>
            <a:ext cx="6960870" cy="1162367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7457C-3A5A-40D5-82FA-555B7446A59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54632-73CF-468C-9C4F-0532F376B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597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7457C-3A5A-40D5-82FA-555B7446A59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54632-73CF-468C-9C4F-0532F376B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435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8666" y="3419479"/>
            <a:ext cx="9464040" cy="5705474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8666" y="9178929"/>
            <a:ext cx="9464040" cy="3000374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/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7457C-3A5A-40D5-82FA-555B7446A59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54632-73CF-468C-9C4F-0532F376B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687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4380" y="3651250"/>
            <a:ext cx="466344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54980" y="3651250"/>
            <a:ext cx="466344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7457C-3A5A-40D5-82FA-555B7446A59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54632-73CF-468C-9C4F-0532F376B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600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730253"/>
            <a:ext cx="9464040" cy="265112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5810" y="3362326"/>
            <a:ext cx="4642008" cy="164782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5810" y="5010150"/>
            <a:ext cx="4642008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54981" y="3362326"/>
            <a:ext cx="4664869" cy="164782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54981" y="5010150"/>
            <a:ext cx="4664869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7457C-3A5A-40D5-82FA-555B7446A59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54632-73CF-468C-9C4F-0532F376B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429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7457C-3A5A-40D5-82FA-555B7446A59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54632-73CF-468C-9C4F-0532F376B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5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7457C-3A5A-40D5-82FA-555B7446A59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54632-73CF-468C-9C4F-0532F376B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804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914400"/>
            <a:ext cx="3539014" cy="320040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64869" y="1974853"/>
            <a:ext cx="5554980" cy="9747250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4114800"/>
            <a:ext cx="3539014" cy="762317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7457C-3A5A-40D5-82FA-555B7446A59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54632-73CF-468C-9C4F-0532F376B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333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914400"/>
            <a:ext cx="3539014" cy="320040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64869" y="1974853"/>
            <a:ext cx="5554980" cy="9747250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4114800"/>
            <a:ext cx="3539014" cy="762317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7457C-3A5A-40D5-82FA-555B7446A59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54632-73CF-468C-9C4F-0532F376B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812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4380" y="730253"/>
            <a:ext cx="946404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380" y="3651250"/>
            <a:ext cx="946404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4380" y="12712703"/>
            <a:ext cx="246888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E7457C-3A5A-40D5-82FA-555B7446A595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34740" y="12712703"/>
            <a:ext cx="370332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49540" y="12712703"/>
            <a:ext cx="246888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354632-73CF-468C-9C4F-0532F376B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5457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C4ABE93F-68E7-4F72-9948-64346D7EE6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9893" y="893576"/>
            <a:ext cx="5715000" cy="3514725"/>
          </a:xfrm>
          <a:prstGeom prst="rect">
            <a:avLst/>
          </a:prstGeom>
        </p:spPr>
      </p:pic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A594F0E0-613F-4BEB-89B5-66E6F05E36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1817310"/>
              </p:ext>
            </p:extLst>
          </p:nvPr>
        </p:nvGraphicFramePr>
        <p:xfrm>
          <a:off x="757450" y="5075787"/>
          <a:ext cx="5472121" cy="4284311"/>
        </p:xfrm>
        <a:graphic>
          <a:graphicData uri="http://schemas.openxmlformats.org/drawingml/2006/table">
            <a:tbl>
              <a:tblPr firstRow="1" bandRow="1">
                <a:tableStyleId>{00A15C55-8517-42AA-B614-E9B94910E393}</a:tableStyleId>
              </a:tblPr>
              <a:tblGrid>
                <a:gridCol w="1481384">
                  <a:extLst>
                    <a:ext uri="{9D8B030D-6E8A-4147-A177-3AD203B41FA5}">
                      <a16:colId xmlns:a16="http://schemas.microsoft.com/office/drawing/2014/main" val="3001686828"/>
                    </a:ext>
                  </a:extLst>
                </a:gridCol>
                <a:gridCol w="871475">
                  <a:extLst>
                    <a:ext uri="{9D8B030D-6E8A-4147-A177-3AD203B41FA5}">
                      <a16:colId xmlns:a16="http://schemas.microsoft.com/office/drawing/2014/main" val="3009605798"/>
                    </a:ext>
                  </a:extLst>
                </a:gridCol>
                <a:gridCol w="801946">
                  <a:extLst>
                    <a:ext uri="{9D8B030D-6E8A-4147-A177-3AD203B41FA5}">
                      <a16:colId xmlns:a16="http://schemas.microsoft.com/office/drawing/2014/main" val="102264350"/>
                    </a:ext>
                  </a:extLst>
                </a:gridCol>
                <a:gridCol w="875539">
                  <a:extLst>
                    <a:ext uri="{9D8B030D-6E8A-4147-A177-3AD203B41FA5}">
                      <a16:colId xmlns:a16="http://schemas.microsoft.com/office/drawing/2014/main" val="2564596336"/>
                    </a:ext>
                  </a:extLst>
                </a:gridCol>
                <a:gridCol w="1441777">
                  <a:extLst>
                    <a:ext uri="{9D8B030D-6E8A-4147-A177-3AD203B41FA5}">
                      <a16:colId xmlns:a16="http://schemas.microsoft.com/office/drawing/2014/main" val="1771556115"/>
                    </a:ext>
                  </a:extLst>
                </a:gridCol>
              </a:tblGrid>
              <a:tr h="547339">
                <a:tc>
                  <a:txBody>
                    <a:bodyPr/>
                    <a:lstStyle/>
                    <a:p>
                      <a:pPr marL="0" lvl="1" algn="ctr" fontAlgn="b"/>
                      <a:r>
                        <a:rPr lang="en-US" sz="1600" b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tty acid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marL="0" lvl="1" algn="ctr" fontAlgn="b"/>
                      <a:r>
                        <a:rPr lang="en-US" sz="1600" b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0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marL="0" lvl="1" algn="ctr" fontAlgn="b"/>
                      <a:r>
                        <a:rPr lang="en-US" sz="1600" b="1" u="none" strike="noStrike">
                          <a:solidFill>
                            <a:srgbClr val="F4B08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  <a:endParaRPr lang="en-US" sz="1600" b="1" i="0" u="none" strike="noStrike">
                        <a:solidFill>
                          <a:srgbClr val="F4B084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marL="0" lvl="1" algn="ctr" fontAlgn="b"/>
                      <a:r>
                        <a:rPr lang="en-US" sz="1600" b="1" u="none" strike="noStrike">
                          <a:solidFill>
                            <a:srgbClr val="8EA9DB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  <a:endParaRPr lang="en-US" sz="1600" b="1" i="0" u="none" strike="noStrike">
                        <a:solidFill>
                          <a:srgbClr val="8EA9D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marL="0" lvl="1" algn="ctr" fontAlgn="b"/>
                      <a:r>
                        <a:rPr lang="en-US" sz="1600" b="1" i="0" u="none" strike="noStrike">
                          <a:solidFill>
                            <a:srgbClr val="8EA9DB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 (M2/M1)</a:t>
                      </a:r>
                    </a:p>
                  </a:txBody>
                  <a:tcPr marL="19050" marR="19050" marT="19050" marB="0" anchor="ctr"/>
                </a:tc>
                <a:extLst>
                  <a:ext uri="{0D108BD9-81ED-4DB2-BD59-A6C34878D82A}">
                    <a16:rowId xmlns:a16="http://schemas.microsoft.com/office/drawing/2014/main" val="402440975"/>
                  </a:ext>
                </a:extLst>
              </a:tr>
              <a:tr h="369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etic acid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39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292</a:t>
                      </a:r>
                      <a:endParaRPr lang="en-US" sz="1600" b="0" i="0" u="none" strike="noStrike">
                        <a:solidFill>
                          <a:srgbClr val="F4B084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809</a:t>
                      </a:r>
                      <a:endParaRPr lang="en-US" sz="1600" b="0" i="0" u="none" strike="noStrike">
                        <a:solidFill>
                          <a:srgbClr val="8EA9D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109728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E-01</a:t>
                      </a:r>
                      <a:endParaRPr lang="en-US" sz="16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extLst>
                  <a:ext uri="{0D108BD9-81ED-4DB2-BD59-A6C34878D82A}">
                    <a16:rowId xmlns:a16="http://schemas.microsoft.com/office/drawing/2014/main" val="1866807408"/>
                  </a:ext>
                </a:extLst>
              </a:tr>
              <a:tr h="3723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pionic acid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546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976</a:t>
                      </a:r>
                      <a:endParaRPr lang="en-US" sz="1600" b="0" i="0" u="none" strike="noStrike">
                        <a:solidFill>
                          <a:srgbClr val="F4B084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230</a:t>
                      </a:r>
                      <a:endParaRPr lang="en-US" sz="1600" b="0" i="0" u="none" strike="noStrike">
                        <a:solidFill>
                          <a:srgbClr val="8EA9D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109728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3E-01</a:t>
                      </a:r>
                      <a:endParaRPr lang="en-US" sz="16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extLst>
                  <a:ext uri="{0D108BD9-81ED-4DB2-BD59-A6C34878D82A}">
                    <a16:rowId xmlns:a16="http://schemas.microsoft.com/office/drawing/2014/main" val="2635927574"/>
                  </a:ext>
                </a:extLst>
              </a:tr>
              <a:tr h="369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tyric acid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90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869</a:t>
                      </a:r>
                      <a:endParaRPr lang="en-US" sz="1600" b="0" i="0" u="none" strike="noStrike">
                        <a:solidFill>
                          <a:srgbClr val="F4B084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859</a:t>
                      </a:r>
                      <a:endParaRPr lang="en-US" sz="1600" b="0" i="0" u="none" strike="noStrike">
                        <a:solidFill>
                          <a:srgbClr val="8EA9D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109728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9E-04</a:t>
                      </a:r>
                      <a:endParaRPr lang="en-US" sz="16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extLst>
                  <a:ext uri="{0D108BD9-81ED-4DB2-BD59-A6C34878D82A}">
                    <a16:rowId xmlns:a16="http://schemas.microsoft.com/office/drawing/2014/main" val="3378226757"/>
                  </a:ext>
                </a:extLst>
              </a:tr>
              <a:tr h="3723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ntanoic</a:t>
                      </a:r>
                      <a:r>
                        <a:rPr lang="en-US" sz="16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cid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7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10</a:t>
                      </a:r>
                      <a:endParaRPr lang="en-US" sz="1600" b="0" i="0" u="none" strike="noStrike">
                        <a:solidFill>
                          <a:srgbClr val="F4B084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212</a:t>
                      </a:r>
                      <a:endParaRPr lang="en-US" sz="1600" b="0" i="0" u="none" strike="noStrike">
                        <a:solidFill>
                          <a:srgbClr val="8EA9D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4E-02</a:t>
                      </a:r>
                      <a:endParaRPr lang="en-US" sz="16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extLst>
                  <a:ext uri="{0D108BD9-81ED-4DB2-BD59-A6C34878D82A}">
                    <a16:rowId xmlns:a16="http://schemas.microsoft.com/office/drawing/2014/main" val="1559164706"/>
                  </a:ext>
                </a:extLst>
              </a:tr>
              <a:tr h="3723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xanoic acid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40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952</a:t>
                      </a:r>
                      <a:endParaRPr lang="en-US" sz="1600" b="0" i="0" u="none" strike="noStrike">
                        <a:solidFill>
                          <a:srgbClr val="F4B084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314</a:t>
                      </a:r>
                      <a:endParaRPr lang="en-US" sz="1600" b="0" i="0" u="none" strike="noStrike">
                        <a:solidFill>
                          <a:srgbClr val="8EA9D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8E-09</a:t>
                      </a:r>
                      <a:endParaRPr lang="en-US" sz="16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288" marR="14288" marT="14288" marB="0" anchor="ctr"/>
                </a:tc>
                <a:extLst>
                  <a:ext uri="{0D108BD9-81ED-4DB2-BD59-A6C34878D82A}">
                    <a16:rowId xmlns:a16="http://schemas.microsoft.com/office/drawing/2014/main" val="274006691"/>
                  </a:ext>
                </a:extLst>
              </a:tr>
              <a:tr h="369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lmitic acid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66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29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68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6E-07</a:t>
                      </a:r>
                    </a:p>
                  </a:txBody>
                  <a:tcPr marL="14288" marR="14288" marT="14288" marB="0" anchor="ctr"/>
                </a:tc>
                <a:extLst>
                  <a:ext uri="{0D108BD9-81ED-4DB2-BD59-A6C34878D82A}">
                    <a16:rowId xmlns:a16="http://schemas.microsoft.com/office/drawing/2014/main" val="1608539203"/>
                  </a:ext>
                </a:extLst>
              </a:tr>
              <a:tr h="4028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lmitoleic acid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53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39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46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0E-07</a:t>
                      </a:r>
                    </a:p>
                  </a:txBody>
                  <a:tcPr marL="14288" marR="14288" marT="14288" marB="0" anchor="ctr"/>
                </a:tc>
                <a:extLst>
                  <a:ext uri="{0D108BD9-81ED-4DB2-BD59-A6C34878D82A}">
                    <a16:rowId xmlns:a16="http://schemas.microsoft.com/office/drawing/2014/main" val="1072843298"/>
                  </a:ext>
                </a:extLst>
              </a:tr>
              <a:tr h="369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HNE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5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3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4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0E-07</a:t>
                      </a:r>
                    </a:p>
                  </a:txBody>
                  <a:tcPr marL="14288" marR="14288" marT="14288" marB="0" anchor="ctr"/>
                </a:tc>
                <a:extLst>
                  <a:ext uri="{0D108BD9-81ED-4DB2-BD59-A6C34878D82A}">
                    <a16:rowId xmlns:a16="http://schemas.microsoft.com/office/drawing/2014/main" val="2205003307"/>
                  </a:ext>
                </a:extLst>
              </a:tr>
              <a:tr h="369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S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3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0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2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5E-3</a:t>
                      </a:r>
                    </a:p>
                  </a:txBody>
                  <a:tcPr marL="14288" marR="14288" marT="14288" marB="0" anchor="ctr"/>
                </a:tc>
                <a:extLst>
                  <a:ext uri="{0D108BD9-81ED-4DB2-BD59-A6C34878D82A}">
                    <a16:rowId xmlns:a16="http://schemas.microsoft.com/office/drawing/2014/main" val="2737015018"/>
                  </a:ext>
                </a:extLst>
              </a:tr>
              <a:tr h="369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KB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2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0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3</a:t>
                      </a:r>
                    </a:p>
                  </a:txBody>
                  <a:tcPr marL="14288" marR="14288" marT="142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E-2</a:t>
                      </a:r>
                    </a:p>
                  </a:txBody>
                  <a:tcPr marL="14288" marR="14288" marT="14288" marB="0" anchor="ctr"/>
                </a:tc>
                <a:extLst>
                  <a:ext uri="{0D108BD9-81ED-4DB2-BD59-A6C34878D82A}">
                    <a16:rowId xmlns:a16="http://schemas.microsoft.com/office/drawing/2014/main" val="2804073892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02A2CFE7-4D0C-4BA0-85F8-9AB97A1CF22E}"/>
              </a:ext>
            </a:extLst>
          </p:cNvPr>
          <p:cNvSpPr txBox="1"/>
          <p:nvPr/>
        </p:nvSpPr>
        <p:spPr>
          <a:xfrm>
            <a:off x="9118832" y="2575210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1.1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1C2FF76-3B50-4D50-943B-90BC2F4D1CA7}"/>
              </a:ext>
            </a:extLst>
          </p:cNvPr>
          <p:cNvSpPr txBox="1"/>
          <p:nvPr/>
        </p:nvSpPr>
        <p:spPr>
          <a:xfrm>
            <a:off x="9096453" y="3978041"/>
            <a:ext cx="6527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-1.1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C561EF9-7BBD-45F1-97EE-FB917CC080C1}"/>
              </a:ext>
            </a:extLst>
          </p:cNvPr>
          <p:cNvSpPr txBox="1"/>
          <p:nvPr/>
        </p:nvSpPr>
        <p:spPr>
          <a:xfrm rot="16200000">
            <a:off x="7899006" y="3327250"/>
            <a:ext cx="1460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600" baseline="-25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(M2/M1)</a:t>
            </a:r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DEF6B741-FF37-4B29-825D-19A90AF4A7A0}"/>
              </a:ext>
            </a:extLst>
          </p:cNvPr>
          <p:cNvSpPr/>
          <p:nvPr/>
        </p:nvSpPr>
        <p:spPr>
          <a:xfrm rot="1960642">
            <a:off x="6070298" y="1465706"/>
            <a:ext cx="1609809" cy="2786287"/>
          </a:xfrm>
          <a:prstGeom prst="ellipse">
            <a:avLst/>
          </a:prstGeom>
          <a:solidFill>
            <a:schemeClr val="accent1">
              <a:alpha val="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70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769D618-5077-4084-BCE0-C03C09B709DD}"/>
              </a:ext>
            </a:extLst>
          </p:cNvPr>
          <p:cNvSpPr txBox="1"/>
          <p:nvPr/>
        </p:nvSpPr>
        <p:spPr>
          <a:xfrm>
            <a:off x="6917320" y="835810"/>
            <a:ext cx="2775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utathione detoxificatio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1462415-B2E3-4E3B-A70A-8BA50CCF62E0}"/>
              </a:ext>
            </a:extLst>
          </p:cNvPr>
          <p:cNvSpPr txBox="1"/>
          <p:nvPr/>
        </p:nvSpPr>
        <p:spPr>
          <a:xfrm>
            <a:off x="7315771" y="1159006"/>
            <a:ext cx="1774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S formation </a:t>
            </a:r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13C7E486-4B7B-4989-B419-7B2AF4517FC4}"/>
              </a:ext>
            </a:extLst>
          </p:cNvPr>
          <p:cNvSpPr/>
          <p:nvPr/>
        </p:nvSpPr>
        <p:spPr>
          <a:xfrm rot="6302220">
            <a:off x="3429832" y="234439"/>
            <a:ext cx="1950490" cy="3134261"/>
          </a:xfrm>
          <a:prstGeom prst="ellipse">
            <a:avLst/>
          </a:prstGeom>
          <a:solidFill>
            <a:schemeClr val="accent1">
              <a:alpha val="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70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CBCE75C-5910-47A1-BD5E-9DF34277C5B9}"/>
              </a:ext>
            </a:extLst>
          </p:cNvPr>
          <p:cNvSpPr txBox="1"/>
          <p:nvPr/>
        </p:nvSpPr>
        <p:spPr>
          <a:xfrm>
            <a:off x="4171381" y="481023"/>
            <a:ext cx="2233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tty </a:t>
            </a:r>
            <a:r>
              <a:rPr 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r>
              <a:rPr lang="en-US" sz="16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16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Oxidation</a:t>
            </a: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45C18878-3E45-446B-B360-A1D24B6A2C11}"/>
              </a:ext>
            </a:extLst>
          </p:cNvPr>
          <p:cNvSpPr/>
          <p:nvPr/>
        </p:nvSpPr>
        <p:spPr>
          <a:xfrm rot="6272776">
            <a:off x="2341938" y="2052468"/>
            <a:ext cx="1433168" cy="2028154"/>
          </a:xfrm>
          <a:prstGeom prst="ellipse">
            <a:avLst/>
          </a:prstGeom>
          <a:solidFill>
            <a:schemeClr val="accent1">
              <a:alpha val="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70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BAF9ADF-198C-4BD8-AC6D-4FF98DD17A73}"/>
              </a:ext>
            </a:extLst>
          </p:cNvPr>
          <p:cNvSpPr txBox="1"/>
          <p:nvPr/>
        </p:nvSpPr>
        <p:spPr>
          <a:xfrm>
            <a:off x="1107190" y="1834841"/>
            <a:ext cx="124906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tty acid </a:t>
            </a:r>
          </a:p>
          <a:p>
            <a:r>
              <a:rPr lang="en-US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ongatio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6727EB7-785F-4079-8937-F607F2594DAA}"/>
              </a:ext>
            </a:extLst>
          </p:cNvPr>
          <p:cNvSpPr txBox="1"/>
          <p:nvPr/>
        </p:nvSpPr>
        <p:spPr>
          <a:xfrm>
            <a:off x="124799" y="94496"/>
            <a:ext cx="44114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0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96A2684-524D-4033-B270-D41DA91CEAF1}"/>
              </a:ext>
            </a:extLst>
          </p:cNvPr>
          <p:cNvSpPr txBox="1"/>
          <p:nvPr/>
        </p:nvSpPr>
        <p:spPr>
          <a:xfrm>
            <a:off x="120547" y="4616638"/>
            <a:ext cx="44114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67FF881-BE59-4F14-90A1-FD2826AAD06A}"/>
              </a:ext>
            </a:extLst>
          </p:cNvPr>
          <p:cNvSpPr txBox="1"/>
          <p:nvPr/>
        </p:nvSpPr>
        <p:spPr>
          <a:xfrm>
            <a:off x="6521363" y="4616638"/>
            <a:ext cx="46198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15170AE1-3325-4F4F-A6B7-82FD9559C1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8355635" y="3376829"/>
            <a:ext cx="1318108" cy="222869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9EC77FAC-98F7-41C9-AF34-A5C9C599FC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20427" y="9753542"/>
            <a:ext cx="5924466" cy="3682776"/>
          </a:xfrm>
          <a:prstGeom prst="rect">
            <a:avLst/>
          </a:prstGeom>
        </p:spPr>
      </p:pic>
      <p:sp>
        <p:nvSpPr>
          <p:cNvPr id="30" name="Oval 29">
            <a:extLst>
              <a:ext uri="{FF2B5EF4-FFF2-40B4-BE49-F238E27FC236}">
                <a16:creationId xmlns:a16="http://schemas.microsoft.com/office/drawing/2014/main" id="{1E049ECF-1A3B-405E-AAFF-63C849EF1D81}"/>
              </a:ext>
            </a:extLst>
          </p:cNvPr>
          <p:cNvSpPr/>
          <p:nvPr/>
        </p:nvSpPr>
        <p:spPr>
          <a:xfrm rot="1960642">
            <a:off x="5865501" y="10461411"/>
            <a:ext cx="1812928" cy="3102524"/>
          </a:xfrm>
          <a:prstGeom prst="ellipse">
            <a:avLst/>
          </a:prstGeom>
          <a:solidFill>
            <a:schemeClr val="accent1">
              <a:alpha val="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70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77FE41D7-DEC2-4CE2-BA96-A0D254AFE281}"/>
              </a:ext>
            </a:extLst>
          </p:cNvPr>
          <p:cNvSpPr/>
          <p:nvPr/>
        </p:nvSpPr>
        <p:spPr>
          <a:xfrm rot="6272776">
            <a:off x="2082596" y="10998595"/>
            <a:ext cx="1433168" cy="2028154"/>
          </a:xfrm>
          <a:prstGeom prst="ellipse">
            <a:avLst/>
          </a:prstGeom>
          <a:solidFill>
            <a:schemeClr val="accent1">
              <a:alpha val="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70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C008B2F1-0079-4162-A492-66DDAAD350C9}"/>
              </a:ext>
            </a:extLst>
          </p:cNvPr>
          <p:cNvSpPr/>
          <p:nvPr/>
        </p:nvSpPr>
        <p:spPr>
          <a:xfrm rot="6208178">
            <a:off x="3244313" y="9233357"/>
            <a:ext cx="1948038" cy="3019160"/>
          </a:xfrm>
          <a:prstGeom prst="ellipse">
            <a:avLst/>
          </a:prstGeom>
          <a:solidFill>
            <a:schemeClr val="accent1">
              <a:alpha val="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70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39190DD-9342-4458-AA09-46D3F27A2F20}"/>
              </a:ext>
            </a:extLst>
          </p:cNvPr>
          <p:cNvSpPr txBox="1"/>
          <p:nvPr/>
        </p:nvSpPr>
        <p:spPr>
          <a:xfrm>
            <a:off x="8815529" y="11079426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1.1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7314466-C0A5-424C-B8F0-5BC07C82F6B1}"/>
              </a:ext>
            </a:extLst>
          </p:cNvPr>
          <p:cNvSpPr txBox="1"/>
          <p:nvPr/>
        </p:nvSpPr>
        <p:spPr>
          <a:xfrm>
            <a:off x="8793150" y="12482257"/>
            <a:ext cx="6527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-1.1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914B017-7482-4086-919F-AAB713FD2B01}"/>
              </a:ext>
            </a:extLst>
          </p:cNvPr>
          <p:cNvSpPr txBox="1"/>
          <p:nvPr/>
        </p:nvSpPr>
        <p:spPr>
          <a:xfrm rot="16200000">
            <a:off x="7595703" y="11831466"/>
            <a:ext cx="1460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600" baseline="-25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(M1/M0)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BBD20673-04D4-4C2E-84A8-B65A58C642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8052332" y="11881045"/>
            <a:ext cx="1318108" cy="222869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AED18CEC-B76A-4100-BCCB-62225CC9C949}"/>
              </a:ext>
            </a:extLst>
          </p:cNvPr>
          <p:cNvSpPr txBox="1"/>
          <p:nvPr/>
        </p:nvSpPr>
        <p:spPr>
          <a:xfrm>
            <a:off x="142104" y="9393608"/>
            <a:ext cx="46198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00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CF6E3F3-B82D-45A1-B983-CEAFF264019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7494" y="5309505"/>
            <a:ext cx="3745034" cy="37394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3123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Pre_x002d_Migration_x0020_Date_x0020_Modified xmlns="28efd9a5-36d1-447d-b6ab-9aa3cf4b04aa" xsi:nil="true"/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CC90A9DEFCF0047BEEE0A269CDD5246" ma:contentTypeVersion="15" ma:contentTypeDescription="Create a new document." ma:contentTypeScope="" ma:versionID="64a4085b5c7b62ba3872c00eaf7edf8a">
  <xsd:schema xmlns:xsd="http://www.w3.org/2001/XMLSchema" xmlns:xs="http://www.w3.org/2001/XMLSchema" xmlns:p="http://schemas.microsoft.com/office/2006/metadata/properties" xmlns:ns1="http://schemas.microsoft.com/sharepoint/v3" xmlns:ns3="46c218e9-f371-4985-bf81-27f1a9e04205" xmlns:ns4="28efd9a5-36d1-447d-b6ab-9aa3cf4b04aa" targetNamespace="http://schemas.microsoft.com/office/2006/metadata/properties" ma:root="true" ma:fieldsID="9271ac9f2e1ec529685b93cb9039fd18" ns1:_="" ns3:_="" ns4:_="">
    <xsd:import namespace="http://schemas.microsoft.com/sharepoint/v3"/>
    <xsd:import namespace="46c218e9-f371-4985-bf81-27f1a9e04205"/>
    <xsd:import namespace="28efd9a5-36d1-447d-b6ab-9aa3cf4b04aa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Pre_x002d_Migration_x0020_Date_x0020_Modified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1:_ip_UnifiedCompliancePolicyProperties" minOccurs="0"/>
                <xsd:element ref="ns1:_ip_UnifiedCompliancePolicyUIAction" minOccurs="0"/>
                <xsd:element ref="ns4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20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21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6c218e9-f371-4985-bf81-27f1a9e04205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8efd9a5-36d1-447d-b6ab-9aa3cf4b04a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Pre_x002d_Migration_x0020_Date_x0020_Modified" ma:index="15" nillable="true" ma:displayName="Pre-Migration Date Modified" ma:internalName="Pre_x002d_Migration_x0020_Date_x0020_Modified">
      <xsd:simpleType>
        <xsd:restriction base="dms:DateTime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2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D1E37937-2485-4372-92C8-BC6F022BE64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BA46C84-CD61-4B17-9BE0-C942A954D0E3}">
  <ds:schemaRefs>
    <ds:schemaRef ds:uri="http://schemas.openxmlformats.org/package/2006/metadata/core-properties"/>
    <ds:schemaRef ds:uri="46c218e9-f371-4985-bf81-27f1a9e04205"/>
    <ds:schemaRef ds:uri="http://purl.org/dc/elements/1.1/"/>
    <ds:schemaRef ds:uri="http://schemas.microsoft.com/office/2006/metadata/properties"/>
    <ds:schemaRef ds:uri="28efd9a5-36d1-447d-b6ab-9aa3cf4b04aa"/>
    <ds:schemaRef ds:uri="http://purl.org/dc/terms/"/>
    <ds:schemaRef ds:uri="http://schemas.microsoft.com/sharepoint/v3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B8905B65-D7D9-4106-9F05-C1C6A3C41260}">
  <ds:schemaRefs>
    <ds:schemaRef ds:uri="28efd9a5-36d1-447d-b6ab-9aa3cf4b04aa"/>
    <ds:schemaRef ds:uri="46c218e9-f371-4985-bf81-27f1a9e0420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microsoft.com/sharepoint/v3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1</TotalTime>
  <Words>102</Words>
  <Application>Microsoft Office PowerPoint</Application>
  <PresentationFormat>Custom</PresentationFormat>
  <Paragraphs>7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Kangling</dc:creator>
  <cp:lastModifiedBy>Zhang, Kangling</cp:lastModifiedBy>
  <cp:revision>3</cp:revision>
  <dcterms:created xsi:type="dcterms:W3CDTF">2021-10-07T22:54:37Z</dcterms:created>
  <dcterms:modified xsi:type="dcterms:W3CDTF">2022-08-20T22:11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CC90A9DEFCF0047BEEE0A269CDD5246</vt:lpwstr>
  </property>
</Properties>
</file>